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2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aximized">
    <p:restoredLeft sz="13560" autoAdjust="0"/>
    <p:restoredTop sz="79680" autoAdjust="0"/>
  </p:normalViewPr>
  <p:slideViewPr>
    <p:cSldViewPr>
      <p:cViewPr>
        <p:scale>
          <a:sx n="156" d="100"/>
          <a:sy n="156" d="100"/>
        </p:scale>
        <p:origin x="-1088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75D34E-A6F0-40B6-B9BF-F28BC9490060}" type="datetimeFigureOut">
              <a:rPr lang="en-US" smtClean="0"/>
              <a:t>13/8/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1B78C3-A112-42A1-81C1-EAE56F96F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49881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7. Percent amino acid homology of vertebrate (A) VPAC</a:t>
            </a:r>
            <a:r>
              <a:rPr lang="en-US" sz="1200" b="1" baseline="-25000" dirty="0" smtClean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, (B) VPAC</a:t>
            </a:r>
            <a:r>
              <a:rPr lang="en-US" sz="1200" b="1" baseline="-25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and (C) PAC</a:t>
            </a:r>
            <a:r>
              <a:rPr lang="en-US" sz="1200" b="1" baseline="-25000" dirty="0" smtClean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receptors.</a:t>
            </a:r>
            <a:endParaRPr lang="en-US" sz="1200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1B78C3-A112-42A1-81C1-EAE56F96F99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5856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6234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5569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289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794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3179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730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0326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56475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925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82018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9891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2B82EB-CA33-4117-954D-C6E0DC1F7C83}" type="datetimeFigureOut">
              <a:rPr lang="en-US" smtClean="0"/>
              <a:t>13/8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851F44-00E8-46B3-965D-ACE94E07A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780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oup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3895783"/>
              </p:ext>
            </p:extLst>
          </p:nvPr>
        </p:nvGraphicFramePr>
        <p:xfrm>
          <a:off x="298451" y="727642"/>
          <a:ext cx="6364285" cy="2273299"/>
        </p:xfrm>
        <a:graphic>
          <a:graphicData uri="http://schemas.openxmlformats.org/drawingml/2006/table">
            <a:tbl>
              <a:tblPr/>
              <a:tblGrid>
                <a:gridCol w="670261"/>
                <a:gridCol w="65110"/>
                <a:gridCol w="583446"/>
                <a:gridCol w="700901"/>
                <a:gridCol w="665155"/>
                <a:gridCol w="671538"/>
                <a:gridCol w="557912"/>
                <a:gridCol w="580893"/>
                <a:gridCol w="623023"/>
                <a:gridCol w="623023"/>
                <a:gridCol w="623023"/>
              </a:tblGrid>
              <a:tr h="24384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</a:rPr>
                        <a:t>Species</a:t>
                      </a: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  Human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t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Chicken</a:t>
                      </a:r>
                      <a:r>
                        <a:rPr kumimoji="0" lang="en-US" altLang="zh-TW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400" b="1" i="1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.ridibunda</a:t>
                      </a:r>
                      <a:endParaRPr kumimoji="0" lang="en-US" altLang="zh-TW" sz="1400" b="1" i="1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 Goldfish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Dogfish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fVPACa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fVPACb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jlpVPAC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00659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uman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4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83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4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304800" algn="l"/>
                        </a:tabLst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0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7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8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5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8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t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5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1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171450" algn="l"/>
                          <a:tab pos="263525" algn="ctr"/>
                        </a:tabLst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7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171450" algn="l"/>
                          <a:tab pos="263525" algn="ctr"/>
                        </a:tabLst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9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171450" algn="l"/>
                          <a:tab pos="263525" algn="ctr"/>
                        </a:tabLst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6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171450" algn="l"/>
                          <a:tab pos="263525" algn="ctr"/>
                        </a:tabLst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7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hicken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76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333375" algn="l"/>
                        </a:tabLst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8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8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2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9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2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1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.ridibunda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9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7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3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7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oldfish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5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3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0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6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Dogfish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2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6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3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fVPACa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6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5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400" b="1" i="0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fVPACb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5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9699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400" b="1" i="0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jlpVPAC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5" name="Group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13485556"/>
              </p:ext>
            </p:extLst>
          </p:nvPr>
        </p:nvGraphicFramePr>
        <p:xfrm>
          <a:off x="304800" y="3502661"/>
          <a:ext cx="6364285" cy="2273299"/>
        </p:xfrm>
        <a:graphic>
          <a:graphicData uri="http://schemas.openxmlformats.org/drawingml/2006/table">
            <a:tbl>
              <a:tblPr/>
              <a:tblGrid>
                <a:gridCol w="670261"/>
                <a:gridCol w="65110"/>
                <a:gridCol w="583446"/>
                <a:gridCol w="700901"/>
                <a:gridCol w="665155"/>
                <a:gridCol w="671538"/>
                <a:gridCol w="557912"/>
                <a:gridCol w="580893"/>
                <a:gridCol w="623023"/>
                <a:gridCol w="623023"/>
                <a:gridCol w="623023"/>
              </a:tblGrid>
              <a:tr h="24384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</a:rPr>
                        <a:t>Species</a:t>
                      </a: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  Human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t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Chicken</a:t>
                      </a:r>
                      <a:r>
                        <a:rPr kumimoji="0" lang="en-US" altLang="zh-TW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400" b="1" i="1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.rugulosa</a:t>
                      </a:r>
                      <a:endParaRPr kumimoji="0" lang="en-US" altLang="zh-TW" sz="1400" b="1" i="1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 Goldfish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Sturgeon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fVPACa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fVPACb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jlpVPAC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00659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uman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4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85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7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304800" algn="l"/>
                        </a:tabLst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1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2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6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3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5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t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70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9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1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171450" algn="l"/>
                          <a:tab pos="263525" algn="ctr"/>
                        </a:tabLst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1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171450" algn="l"/>
                          <a:tab pos="263525" algn="ctr"/>
                        </a:tabLst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5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171450" algn="l"/>
                          <a:tab pos="263525" algn="ctr"/>
                        </a:tabLst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171450" algn="l"/>
                          <a:tab pos="263525" algn="ctr"/>
                        </a:tabLst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5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hicken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5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333375" algn="l"/>
                        </a:tabLst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6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4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5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2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5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1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.rugulosa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4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2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39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2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oldfish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4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2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37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2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Sturgeon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3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39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3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fVPACa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6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5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400" b="1" i="0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fVPACb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5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9699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400" b="1" i="0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jlpVPAC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7" name="Group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4158617"/>
              </p:ext>
            </p:extLst>
          </p:nvPr>
        </p:nvGraphicFramePr>
        <p:xfrm>
          <a:off x="274015" y="6276341"/>
          <a:ext cx="5806373" cy="2029459"/>
        </p:xfrm>
        <a:graphic>
          <a:graphicData uri="http://schemas.openxmlformats.org/drawingml/2006/table">
            <a:tbl>
              <a:tblPr/>
              <a:tblGrid>
                <a:gridCol w="670261"/>
                <a:gridCol w="65110"/>
                <a:gridCol w="583446"/>
                <a:gridCol w="700901"/>
                <a:gridCol w="665155"/>
                <a:gridCol w="671538"/>
                <a:gridCol w="580893"/>
                <a:gridCol w="623023"/>
                <a:gridCol w="623023"/>
                <a:gridCol w="623023"/>
              </a:tblGrid>
              <a:tr h="24384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</a:rPr>
                        <a:t>Species</a:t>
                      </a: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  Human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t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400" b="1" i="1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.ridibunda</a:t>
                      </a:r>
                      <a:r>
                        <a:rPr kumimoji="0" lang="en-US" altLang="zh-TW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Goldfish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Sturgeon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fVPACa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fVPACb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jlpVPAC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00659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uman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4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92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76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304800" algn="l"/>
                        </a:tabLst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7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6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6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3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6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t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75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6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171450" algn="l"/>
                          <a:tab pos="263525" algn="ctr"/>
                        </a:tabLst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6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171450" algn="l"/>
                          <a:tab pos="263525" algn="ctr"/>
                        </a:tabLst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7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171450" algn="l"/>
                          <a:tab pos="263525" algn="ctr"/>
                        </a:tabLst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3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171450" algn="l"/>
                          <a:tab pos="263525" algn="ctr"/>
                        </a:tabLst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6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1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.ridibunda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71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9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8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3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7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oldfish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5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3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3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7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Sturgeon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3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39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3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fVPACa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6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5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400" b="1" i="0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fVPACb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5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9699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400" b="1" i="0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jlpVPAC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0" y="330062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0" y="3073262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0" y="5892662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C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28600" y="454661"/>
            <a:ext cx="1676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VPAC</a:t>
            </a:r>
            <a:r>
              <a:rPr lang="en-US" sz="1200" b="1" baseline="-25000" dirty="0" smtClean="0">
                <a:latin typeface="Arial" pitchFamily="34" charset="0"/>
                <a:cs typeface="Arial" pitchFamily="34" charset="0"/>
              </a:rPr>
              <a:t>1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66700" y="3211761"/>
            <a:ext cx="1676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VPAC</a:t>
            </a:r>
            <a:r>
              <a:rPr lang="en-US" sz="1200" b="1" baseline="-25000" dirty="0">
                <a:latin typeface="Arial" pitchFamily="34" charset="0"/>
                <a:cs typeface="Arial" pitchFamily="34" charset="0"/>
              </a:rPr>
              <a:t>2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28600" y="6017261"/>
            <a:ext cx="1676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PAC</a:t>
            </a:r>
            <a:r>
              <a:rPr lang="en-US" sz="1200" b="1" baseline="-25000" dirty="0">
                <a:latin typeface="Arial" pitchFamily="34" charset="0"/>
                <a:cs typeface="Arial" pitchFamily="34" charset="0"/>
              </a:rPr>
              <a:t>1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0" y="0"/>
            <a:ext cx="7617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Figure S7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3449516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62</TotalTime>
  <Words>226</Words>
  <Application>Microsoft Macintosh PowerPoint</Application>
  <PresentationFormat>On-screen Show (4:3)</PresentationFormat>
  <Paragraphs>19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o</dc:creator>
  <cp:lastModifiedBy>Leo Lee</cp:lastModifiedBy>
  <cp:revision>173</cp:revision>
  <cp:lastPrinted>2011-04-04T08:17:36Z</cp:lastPrinted>
  <dcterms:created xsi:type="dcterms:W3CDTF">2011-03-21T07:06:05Z</dcterms:created>
  <dcterms:modified xsi:type="dcterms:W3CDTF">2012-08-13T03:42:36Z</dcterms:modified>
</cp:coreProperties>
</file>